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6858000" cy="9144000"/>
          </a:xfrm>
          <a:custGeom>
            <a:avLst/>
            <a:gdLst>
              <a:gd name="textAreaLeft" fmla="*/ 360 w 6858000"/>
              <a:gd name="textAreaRight" fmla="*/ 6857640 w 6858000"/>
              <a:gd name="textAreaTop" fmla="*/ 360 h 9144000"/>
              <a:gd name="textAreaBottom" fmla="*/ 9143640 h 9144000"/>
            </a:gdLst>
            <a:ahLst/>
            <a:rect l="textAreaLeft" t="textAreaTop" r="textAreaRight" b="textAreaBottom"/>
            <a:pathLst>
              <a:path w="21600" h="28800">
                <a:moveTo>
                  <a:pt x="5" y="0"/>
                </a:moveTo>
                <a:arcTo wR="5" hR="5" stAng="16200000" swAng="-5400000"/>
                <a:lnTo>
                  <a:pt x="0" y="28795"/>
                </a:lnTo>
                <a:arcTo wR="5" hR="5" stAng="10800000" swAng="-5400000"/>
                <a:lnTo>
                  <a:pt x="21595" y="28800"/>
                </a:lnTo>
                <a:arcTo wR="5" hR="5" stAng="5400000" swAng="-5400000"/>
                <a:lnTo>
                  <a:pt x="21600" y="5"/>
                </a:lnTo>
                <a:arcTo wR="5" hR="5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884760" y="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1"/>
          <p:cNvSpPr>
            <a:spLocks noGrp="1"/>
          </p:cNvSpPr>
          <p:nvPr>
            <p:ph type="sldImg"/>
          </p:nvPr>
        </p:nvSpPr>
        <p:spPr>
          <a:xfrm>
            <a:off x="2142720" y="685440"/>
            <a:ext cx="2570040" cy="3427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496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sldNum" idx="2"/>
          </p:nvPr>
        </p:nvSpPr>
        <p:spPr>
          <a:xfrm>
            <a:off x="3884760" y="8685000"/>
            <a:ext cx="2970000" cy="45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96CC4A63-E713-4419-AB4D-62A9FB6A9AF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6336C9B3-4D53-4D7C-BC97-B1C9018FE23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545DB60B-B0A4-4624-B1D9-5571B112FD5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1"/>
          <p:cNvSpPr>
            <a:spLocks noGrp="1"/>
          </p:cNvSpPr>
          <p:nvPr>
            <p:ph type="sldImg"/>
          </p:nvPr>
        </p:nvSpPr>
        <p:spPr>
          <a:xfrm>
            <a:off x="2197080" y="696960"/>
            <a:ext cx="2616120" cy="3486240"/>
          </a:xfrm>
          <a:prstGeom prst="rect">
            <a:avLst/>
          </a:prstGeom>
          <a:ln w="0">
            <a:noFill/>
          </a:ln>
        </p:spPr>
      </p:sp>
      <p:sp>
        <p:nvSpPr>
          <p:cNvPr id="80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F95CAA5-8AA6-4B15-8538-65B9FAA59AE1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82BA73E-AEDA-419F-BF3E-311D8483236D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0CB8484-4333-4823-A963-A90401511513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886BE3C-F974-40C1-A2A9-AADA44065CC5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579A0D2-E6B9-4ADE-9639-211BE12966D9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E9EE537-DD8D-445C-9DB6-8713DDDB916E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8E0EBD3-CCBA-4DC8-8301-EBA31AD7770C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6F8E9D3-EBFC-4BD7-8EB9-AB7992146634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8F3FA97-F6EE-4F4E-B11D-181486F3F6AE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FF04F45-873C-463C-89C9-94A4A660F9E7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6B8FA0A-88EB-40E2-BE40-3A3447AE79D3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7A4775F-69B9-49CF-AA5F-7CF38F874B65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34308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4915080" y="8326080"/>
            <a:ext cx="1598400" cy="63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2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2518DB50-A06B-4C8C-AEA6-71FB7985D82C}" type="slidenum">
              <a:rPr b="0" lang="en-US" sz="2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119160" y="609480"/>
            <a:ext cx="6662520" cy="784872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914400" y="3505320"/>
            <a:ext cx="1440" cy="15228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838080" y="2971800"/>
            <a:ext cx="1800" cy="15228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838080" y="1828800"/>
            <a:ext cx="1800" cy="15228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449360" y="304920"/>
            <a:ext cx="4359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LATE ELONGATED HYPOCOTYL (LHY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77760" y="2174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"/>
          <p:cNvGrpSpPr/>
          <p:nvPr/>
        </p:nvGrpSpPr>
        <p:grpSpPr>
          <a:xfrm>
            <a:off x="-63360" y="1752480"/>
            <a:ext cx="590040" cy="1798920"/>
            <a:chOff x="-63360" y="1752480"/>
            <a:chExt cx="590040" cy="1798920"/>
          </a:xfrm>
        </p:grpSpPr>
        <p:sp>
          <p:nvSpPr>
            <p:cNvPr id="56" name=""/>
            <p:cNvSpPr/>
            <p:nvPr/>
          </p:nvSpPr>
          <p:spPr>
            <a:xfrm>
              <a:off x="32040" y="1752480"/>
              <a:ext cx="4564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4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-63360" y="2695680"/>
              <a:ext cx="5875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(WT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-12960" y="330516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upf1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0" y="2146320"/>
              <a:ext cx="5266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42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" name=""/>
          <p:cNvSpPr/>
          <p:nvPr/>
        </p:nvSpPr>
        <p:spPr>
          <a:xfrm>
            <a:off x="152280" y="0"/>
            <a:ext cx="6629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US" sz="800" spc="-1" strike="noStrike">
                <a:solidFill>
                  <a:srgbClr val="808080"/>
                </a:solidFill>
                <a:latin typeface="Arial"/>
              </a:rPr>
              <a:t>Additional File 1. Figure S1A</a:t>
            </a:r>
            <a:r>
              <a:rPr b="0" lang="en-US" sz="800" spc="-1" strike="noStrike">
                <a:solidFill>
                  <a:srgbClr val="808080"/>
                </a:solidFill>
                <a:latin typeface="Arial"/>
              </a:rPr>
              <a:t>                                                                                                                                              </a:t>
            </a:r>
            <a:r>
              <a:rPr b="0" i="1" lang="en-US" sz="800" spc="-1" strike="noStrike">
                <a:solidFill>
                  <a:srgbClr val="808080"/>
                </a:solidFill>
                <a:latin typeface="Arial"/>
              </a:rPr>
              <a:t>Filichkin and Mockler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231840" y="609480"/>
            <a:ext cx="6397560" cy="8001000"/>
          </a:xfrm>
          <a:prstGeom prst="rect">
            <a:avLst/>
          </a:prstGeom>
          <a:ln w="0">
            <a:noFill/>
          </a:ln>
        </p:spPr>
      </p:pic>
      <p:sp>
        <p:nvSpPr>
          <p:cNvPr id="62" name=""/>
          <p:cNvSpPr/>
          <p:nvPr/>
        </p:nvSpPr>
        <p:spPr>
          <a:xfrm>
            <a:off x="1908000" y="228600"/>
            <a:ext cx="288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LHY/CCA1-LIKE 1 (LCL1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77760" y="22860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4" name=""/>
          <p:cNvGrpSpPr/>
          <p:nvPr/>
        </p:nvGrpSpPr>
        <p:grpSpPr>
          <a:xfrm>
            <a:off x="12600" y="2089080"/>
            <a:ext cx="590400" cy="1798920"/>
            <a:chOff x="12600" y="2089080"/>
            <a:chExt cx="590400" cy="1798920"/>
          </a:xfrm>
        </p:grpSpPr>
        <p:sp>
          <p:nvSpPr>
            <p:cNvPr id="65" name=""/>
            <p:cNvSpPr/>
            <p:nvPr/>
          </p:nvSpPr>
          <p:spPr>
            <a:xfrm>
              <a:off x="108360" y="2089080"/>
              <a:ext cx="4564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4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2600" y="3032280"/>
              <a:ext cx="5875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(WT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63000" y="364176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upf1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76320" y="2482920"/>
              <a:ext cx="5266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42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9" name=""/>
          <p:cNvSpPr/>
          <p:nvPr/>
        </p:nvSpPr>
        <p:spPr>
          <a:xfrm>
            <a:off x="5259600" y="281952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8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497480" y="236232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7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5400000">
            <a:off x="4619520" y="2165400"/>
            <a:ext cx="136800" cy="380880"/>
          </a:xfrm>
          <a:custGeom>
            <a:avLst/>
            <a:gdLst>
              <a:gd name="textAreaLeft" fmla="*/ 0 w 136800"/>
              <a:gd name="textAreaRight" fmla="*/ 49320 w 136800"/>
              <a:gd name="textAreaTop" fmla="*/ 9720 h 380880"/>
              <a:gd name="textAreaBottom" fmla="*/ 371160 h 3808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486400" y="3048120"/>
            <a:ext cx="1440" cy="15228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5486400" y="3657600"/>
            <a:ext cx="1440" cy="15228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52280" y="0"/>
            <a:ext cx="6629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US" sz="800" spc="-1" strike="noStrike">
                <a:solidFill>
                  <a:srgbClr val="808080"/>
                </a:solidFill>
                <a:latin typeface="Arial"/>
              </a:rPr>
              <a:t>Additional File 1. Figure S1B</a:t>
            </a:r>
            <a:r>
              <a:rPr b="0" lang="en-US" sz="800" spc="-1" strike="noStrike">
                <a:solidFill>
                  <a:srgbClr val="808080"/>
                </a:solidFill>
                <a:latin typeface="Arial"/>
              </a:rPr>
              <a:t>                                                                                                                                              </a:t>
            </a:r>
            <a:r>
              <a:rPr b="0" i="1" lang="en-US" sz="800" spc="-1" strike="noStrike">
                <a:solidFill>
                  <a:srgbClr val="808080"/>
                </a:solidFill>
                <a:latin typeface="Arial"/>
              </a:rPr>
              <a:t>Filichkin and Mockler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3T20:37:30Z</dcterms:created>
  <dc:creator>filichks</dc:creator>
  <dc:description/>
  <dc:language>en-US</dc:language>
  <cp:lastModifiedBy>Todd Mockler</cp:lastModifiedBy>
  <dcterms:modified xsi:type="dcterms:W3CDTF">2011-12-13T15:23:04Z</dcterms:modified>
  <cp:revision>12</cp:revision>
  <dc:subject/>
  <dc:title>Slide 1</dc:title>
</cp:coreProperties>
</file>